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3.xml" ContentType="application/vnd.openxmlformats-officedocument.presentationml.notesSlide+xml"/>
  <Override PartName="/ppt/charts/chartEx1.xml" ContentType="application/vnd.ms-office.chartex+xml"/>
  <Override PartName="/ppt/charts/style3.xml" ContentType="application/vnd.ms-office.chartstyle+xml"/>
  <Override PartName="/ppt/charts/colors3.xml" ContentType="application/vnd.ms-office.chartcolorstyle+xml"/>
  <Override PartName="/ppt/charts/chartEx2.xml" ContentType="application/vnd.ms-office.chartex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337" r:id="rId2"/>
    <p:sldId id="261" r:id="rId3"/>
    <p:sldId id="338" r:id="rId4"/>
    <p:sldId id="335" r:id="rId5"/>
    <p:sldId id="340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113"/>
    <p:restoredTop sz="96197"/>
  </p:normalViewPr>
  <p:slideViewPr>
    <p:cSldViewPr snapToGrid="0" snapToObjects="1">
      <p:cViewPr varScale="1">
        <p:scale>
          <a:sx n="119" d="100"/>
          <a:sy n="119" d="100"/>
        </p:scale>
        <p:origin x="72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9" d="100"/>
        <a:sy n="139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iroyukinunoi/Dropbox/My%20Mac%20(Hiroyuki-no-MacBook-Pro-2.local)/Desktop/H2&#65303;&#31185;&#30740;&#36027;PEG-DAO/PEG-DAO%20english%20rev/IRNUN_1_25122020-1443984/&#26368;&#26032;&#26657;&#27491;/Inflammation/review%20paper/%20rhodamin-BSA/ImageJ&#38754;&#31309;&#27604;&#36611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iroyukinunoi/Dropbox/My%20Mac%20(Hiroyuki-no-MacBook-Pro-2.local)/Desktop/H2&#65303;&#31185;&#30740;&#36027;PEG-DAO/PEG-DAO%20english%20rev/IRNUN_1_25122020-1443984/&#26368;&#26032;&#26657;&#27491;/Inflammation/review%20paper/%20rhodamin-BSA/ImageJ&#38754;&#31309;&#27604;&#36611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file:////Users/hiroyukinunoi/Dropbox/My%20Mac%20(Hiroyuki-no-MacBook-Pro-2.local)/Desktop/H2&#65303;&#31185;&#30740;&#36027;PEG-DAO/PEG-DAO%20english%20rev/IRNUN_1_25122020-1443984/&#26368;&#26032;&#26657;&#27491;/Inflammation/review%20paper/&#30149;&#29702;&#32068;&#32340;/&#23450;&#37327;&#21270;&#38997;&#24494;&#37857;.xlsx" TargetMode="External"/></Relationships>
</file>

<file path=ppt/charts/_rels/chartEx2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file:////Users/hiroyukinunoi/Dropbox/My%20Mac%20(Hiroyuki-no-MacBook-Pro-2.local)/Desktop/H2&#65303;&#31185;&#30740;&#36027;PEG-DAO/PEG-DAO%20english%20rev/IRNUN_1_25122020-1443984/&#26368;&#26032;&#26657;&#27491;/Inflammation/review%20paper/&#30149;&#29702;&#32068;&#32340;/&#23450;&#37327;&#21270;&#38997;&#24494;&#37857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tockChart>
        <c:ser>
          <c:idx val="0"/>
          <c:order val="0"/>
          <c:tx>
            <c:strRef>
              <c:f>Sheet1!$B$5</c:f>
              <c:strCache>
                <c:ptCount val="1"/>
                <c:pt idx="0">
                  <c:v>1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none"/>
          </c:marker>
          <c:cat>
            <c:strRef>
              <c:f>Sheet1!$C$4:$E$4</c:f>
              <c:strCache>
                <c:ptCount val="3"/>
                <c:pt idx="0">
                  <c:v>Control</c:v>
                </c:pt>
                <c:pt idx="1">
                  <c:v>nCA 3</c:v>
                </c:pt>
                <c:pt idx="2">
                  <c:v>PEG 3</c:v>
                </c:pt>
              </c:strCache>
            </c:strRef>
          </c:cat>
          <c:val>
            <c:numRef>
              <c:f>Sheet1!$C$5:$E$5</c:f>
              <c:numCache>
                <c:formatCode>General</c:formatCode>
                <c:ptCount val="3"/>
                <c:pt idx="0">
                  <c:v>1159085</c:v>
                </c:pt>
                <c:pt idx="1">
                  <c:v>3131964</c:v>
                </c:pt>
                <c:pt idx="2">
                  <c:v>16106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0AF-B547-A9D7-B7459F3C8202}"/>
            </c:ext>
          </c:extLst>
        </c:ser>
        <c:ser>
          <c:idx val="1"/>
          <c:order val="1"/>
          <c:tx>
            <c:strRef>
              <c:f>Sheet1!$B$6</c:f>
              <c:strCache>
                <c:ptCount val="1"/>
                <c:pt idx="0">
                  <c:v>2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none"/>
          </c:marker>
          <c:cat>
            <c:strRef>
              <c:f>Sheet1!$C$4:$E$4</c:f>
              <c:strCache>
                <c:ptCount val="3"/>
                <c:pt idx="0">
                  <c:v>Control</c:v>
                </c:pt>
                <c:pt idx="1">
                  <c:v>nCA 3</c:v>
                </c:pt>
                <c:pt idx="2">
                  <c:v>PEG 3</c:v>
                </c:pt>
              </c:strCache>
            </c:strRef>
          </c:cat>
          <c:val>
            <c:numRef>
              <c:f>Sheet1!$C$6:$E$6</c:f>
              <c:numCache>
                <c:formatCode>General</c:formatCode>
                <c:ptCount val="3"/>
                <c:pt idx="0">
                  <c:v>1330132</c:v>
                </c:pt>
                <c:pt idx="1">
                  <c:v>1943795</c:v>
                </c:pt>
                <c:pt idx="2">
                  <c:v>171525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0AF-B547-A9D7-B7459F3C8202}"/>
            </c:ext>
          </c:extLst>
        </c:ser>
        <c:ser>
          <c:idx val="2"/>
          <c:order val="2"/>
          <c:tx>
            <c:strRef>
              <c:f>Sheet1!$B$7</c:f>
              <c:strCache>
                <c:ptCount val="1"/>
                <c:pt idx="0">
                  <c:v>3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ot"/>
            <c:size val="3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Sheet1!$C$4:$E$4</c:f>
              <c:strCache>
                <c:ptCount val="3"/>
                <c:pt idx="0">
                  <c:v>Control</c:v>
                </c:pt>
                <c:pt idx="1">
                  <c:v>nCA 3</c:v>
                </c:pt>
                <c:pt idx="2">
                  <c:v>PEG 3</c:v>
                </c:pt>
              </c:strCache>
            </c:strRef>
          </c:cat>
          <c:val>
            <c:numRef>
              <c:f>Sheet1!$C$7:$E$7</c:f>
              <c:numCache>
                <c:formatCode>General</c:formatCode>
                <c:ptCount val="3"/>
                <c:pt idx="0">
                  <c:v>680718</c:v>
                </c:pt>
                <c:pt idx="1">
                  <c:v>1963227</c:v>
                </c:pt>
                <c:pt idx="2">
                  <c:v>50264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0AF-B547-A9D7-B7459F3C82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07716848"/>
        <c:axId val="907545136"/>
      </c:stockChart>
      <c:catAx>
        <c:axId val="90771684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907545136"/>
        <c:crosses val="autoZero"/>
        <c:auto val="1"/>
        <c:lblAlgn val="ctr"/>
        <c:lblOffset val="100"/>
        <c:noMultiLvlLbl val="0"/>
      </c:catAx>
      <c:valAx>
        <c:axId val="9075451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077168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tockChart>
        <c:ser>
          <c:idx val="0"/>
          <c:order val="0"/>
          <c:tx>
            <c:strRef>
              <c:f>Sheet1!$B$12</c:f>
              <c:strCache>
                <c:ptCount val="1"/>
                <c:pt idx="0">
                  <c:v>1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none"/>
          </c:marker>
          <c:cat>
            <c:strRef>
              <c:f>Sheet1!$C$11:$E$11</c:f>
              <c:strCache>
                <c:ptCount val="3"/>
                <c:pt idx="0">
                  <c:v>Control</c:v>
                </c:pt>
                <c:pt idx="1">
                  <c:v>nCA 3</c:v>
                </c:pt>
                <c:pt idx="2">
                  <c:v>PEG 3</c:v>
                </c:pt>
              </c:strCache>
            </c:strRef>
          </c:cat>
          <c:val>
            <c:numRef>
              <c:f>Sheet1!$C$12:$E$12</c:f>
              <c:numCache>
                <c:formatCode>General</c:formatCode>
                <c:ptCount val="3"/>
                <c:pt idx="0">
                  <c:v>312976</c:v>
                </c:pt>
                <c:pt idx="1">
                  <c:v>648702</c:v>
                </c:pt>
                <c:pt idx="2">
                  <c:v>33074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2DE-9048-8B37-D7969DDB44E9}"/>
            </c:ext>
          </c:extLst>
        </c:ser>
        <c:ser>
          <c:idx val="1"/>
          <c:order val="1"/>
          <c:tx>
            <c:strRef>
              <c:f>Sheet1!$B$13</c:f>
              <c:strCache>
                <c:ptCount val="1"/>
                <c:pt idx="0">
                  <c:v>2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none"/>
          </c:marker>
          <c:cat>
            <c:strRef>
              <c:f>Sheet1!$C$11:$E$11</c:f>
              <c:strCache>
                <c:ptCount val="3"/>
                <c:pt idx="0">
                  <c:v>Control</c:v>
                </c:pt>
                <c:pt idx="1">
                  <c:v>nCA 3</c:v>
                </c:pt>
                <c:pt idx="2">
                  <c:v>PEG 3</c:v>
                </c:pt>
              </c:strCache>
            </c:strRef>
          </c:cat>
          <c:val>
            <c:numRef>
              <c:f>Sheet1!$C$13:$E$13</c:f>
              <c:numCache>
                <c:formatCode>General</c:formatCode>
                <c:ptCount val="3"/>
                <c:pt idx="0">
                  <c:v>260771</c:v>
                </c:pt>
                <c:pt idx="1">
                  <c:v>996188</c:v>
                </c:pt>
                <c:pt idx="2">
                  <c:v>2820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2DE-9048-8B37-D7969DDB44E9}"/>
            </c:ext>
          </c:extLst>
        </c:ser>
        <c:ser>
          <c:idx val="2"/>
          <c:order val="2"/>
          <c:tx>
            <c:strRef>
              <c:f>Sheet1!$B$14</c:f>
              <c:strCache>
                <c:ptCount val="1"/>
                <c:pt idx="0">
                  <c:v>3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ot"/>
            <c:size val="3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Sheet1!$C$11:$E$11</c:f>
              <c:strCache>
                <c:ptCount val="3"/>
                <c:pt idx="0">
                  <c:v>Control</c:v>
                </c:pt>
                <c:pt idx="1">
                  <c:v>nCA 3</c:v>
                </c:pt>
                <c:pt idx="2">
                  <c:v>PEG 3</c:v>
                </c:pt>
              </c:strCache>
            </c:strRef>
          </c:cat>
          <c:val>
            <c:numRef>
              <c:f>Sheet1!$C$14:$E$14</c:f>
              <c:numCache>
                <c:formatCode>General</c:formatCode>
                <c:ptCount val="3"/>
                <c:pt idx="0">
                  <c:v>379426</c:v>
                </c:pt>
                <c:pt idx="1">
                  <c:v>1319972</c:v>
                </c:pt>
                <c:pt idx="2">
                  <c:v>4265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2DE-9048-8B37-D7969DDB44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38100" cap="flat" cmpd="sng" algn="ctr">
              <a:solidFill>
                <a:schemeClr val="accent1">
                  <a:lumMod val="75000"/>
                </a:schemeClr>
              </a:solidFill>
              <a:round/>
            </a:ln>
            <a:effectLst/>
          </c:spPr>
        </c:hiLowLines>
        <c:axId val="752141136"/>
        <c:axId val="752022560"/>
      </c:stockChart>
      <c:catAx>
        <c:axId val="75214113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752022560"/>
        <c:crosses val="autoZero"/>
        <c:auto val="1"/>
        <c:lblAlgn val="ctr"/>
        <c:lblOffset val="100"/>
        <c:noMultiLvlLbl val="0"/>
      </c:catAx>
      <c:valAx>
        <c:axId val="7520225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521411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[定量化顕微鏡.xlsx]有意さ検定!$I$29:$I$38</cx:f>
        <cx:lvl ptCount="10" formatCode="G/標準">
          <cx:pt idx="0">0</cx:pt>
          <cx:pt idx="1">0</cx:pt>
          <cx:pt idx="2">0</cx:pt>
          <cx:pt idx="3">0</cx:pt>
          <cx:pt idx="4">0</cx:pt>
          <cx:pt idx="5">0</cx:pt>
          <cx:pt idx="6">0</cx:pt>
          <cx:pt idx="7">0</cx:pt>
          <cx:pt idx="8">0</cx:pt>
          <cx:pt idx="9">0</cx:pt>
        </cx:lvl>
      </cx:numDim>
    </cx:data>
    <cx:data id="1">
      <cx:numDim type="val">
        <cx:f>[定量化顕微鏡.xlsx]有意さ検定!$J$29:$J$38</cx:f>
        <cx:lvl ptCount="10" formatCode="G/標準">
          <cx:pt idx="0">49</cx:pt>
          <cx:pt idx="1">48</cx:pt>
          <cx:pt idx="2">4</cx:pt>
          <cx:pt idx="3">3</cx:pt>
          <cx:pt idx="4">13</cx:pt>
          <cx:pt idx="5">22</cx:pt>
          <cx:pt idx="6">19</cx:pt>
          <cx:pt idx="7">17</cx:pt>
          <cx:pt idx="8">28</cx:pt>
          <cx:pt idx="9">26</cx:pt>
        </cx:lvl>
      </cx:numDim>
    </cx:data>
    <cx:data id="2">
      <cx:numDim type="val">
        <cx:f>[定量化顕微鏡.xlsx]有意さ検定!$K$29:$K$38</cx:f>
        <cx:lvl ptCount="10" formatCode="G/標準">
          <cx:pt idx="0">6</cx:pt>
          <cx:pt idx="1">2</cx:pt>
          <cx:pt idx="2">5</cx:pt>
          <cx:pt idx="3">3</cx:pt>
          <cx:pt idx="4">4</cx:pt>
          <cx:pt idx="5">6</cx:pt>
          <cx:pt idx="6">3</cx:pt>
          <cx:pt idx="7">2</cx:pt>
          <cx:pt idx="8">6</cx:pt>
        </cx:lvl>
      </cx:numDim>
    </cx:data>
  </cx:chartData>
  <cx:chart>
    <cx:plotArea>
      <cx:plotAreaRegion>
        <cx:plotSurface>
          <cx:spPr>
            <a:solidFill>
              <a:schemeClr val="bg1"/>
            </a:solidFill>
          </cx:spPr>
        </cx:plotSurface>
        <cx:series layoutId="boxWhisker" uniqueId="{259C43EB-ABE2-704E-9486-9F5C73694EBE}">
          <cx:tx>
            <cx:txData>
              <cx:f>[定量化顕微鏡.xlsx]有意さ検定!$I$28</cx:f>
              <cx:v>cont</cx:v>
            </cx:txData>
          </cx:tx>
          <cx:spPr>
            <a:ln>
              <a:solidFill>
                <a:schemeClr val="tx1"/>
              </a:solidFill>
            </a:ln>
          </cx:spPr>
          <cx:dataId val="0"/>
          <cx:layoutPr>
            <cx:visibility meanLine="1" meanMarker="1" nonoutliers="1" outliers="1"/>
            <cx:statistics quartileMethod="inclusive"/>
          </cx:layoutPr>
        </cx:series>
        <cx:series layoutId="boxWhisker" uniqueId="{5466DF25-EBD5-7144-9F68-681B74F44535}">
          <cx:tx>
            <cx:txData>
              <cx:f>[定量化顕微鏡.xlsx]有意さ検定!$J$28</cx:f>
              <cx:v>nCA</cx:v>
            </cx:txData>
          </cx:tx>
          <cx:spPr>
            <a:solidFill>
              <a:schemeClr val="accent2"/>
            </a:solidFill>
            <a:ln>
              <a:solidFill>
                <a:schemeClr val="tx1"/>
              </a:solidFill>
            </a:ln>
          </cx:spPr>
          <cx:dataId val="1"/>
          <cx:layoutPr>
            <cx:visibility meanLine="1" meanMarker="1" nonoutliers="1" outliers="1"/>
            <cx:statistics quartileMethod="exclusive"/>
          </cx:layoutPr>
        </cx:series>
        <cx:series layoutId="boxWhisker" uniqueId="{EEEC7F10-81EB-8440-9B81-C9AC2129A72D}">
          <cx:tx>
            <cx:txData>
              <cx:f>[定量化顕微鏡.xlsx]有意さ検定!$K$28</cx:f>
              <cx:v>PEG-fDAO</cx:v>
            </cx:txData>
          </cx:tx>
          <cx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cx:spPr>
          <cx:dataId val="2"/>
          <cx:layoutPr>
            <cx:visibility meanLine="1" meanMarker="1" nonoutliers="1" outliers="1"/>
            <cx:statistics quartileMethod="exclusive"/>
          </cx:layoutPr>
        </cx:series>
      </cx:plotAreaRegion>
      <cx:axis id="0" hidden="1">
        <cx:catScaling gapWidth="1"/>
        <cx:tickLabels/>
      </cx:axis>
      <cx:axis id="1">
        <cx:valScaling max="60" min="0"/>
        <cx:majorGridlines>
          <cx:spPr>
            <a:ln>
              <a:solidFill>
                <a:schemeClr val="tx1">
                  <a:lumMod val="65000"/>
                  <a:lumOff val="35000"/>
                </a:schemeClr>
              </a:solidFill>
            </a:ln>
          </cx:spPr>
        </cx:majorGridlines>
        <cx:tickLabels/>
        <cx:spPr>
          <a:ln>
            <a:solidFill>
              <a:schemeClr val="tx1"/>
            </a:solidFill>
          </a:ln>
        </cx:spPr>
      </cx:axis>
    </cx:plotArea>
  </cx:chart>
</cx:chartSpace>
</file>

<file path=ppt/charts/chartEx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[定量化顕微鏡.xlsx]有意さ検定!$R$29:$R$38</cx:f>
        <cx:lvl ptCount="10" formatCode="G/標準">
          <cx:pt idx="0">0</cx:pt>
          <cx:pt idx="1">0</cx:pt>
          <cx:pt idx="2">0</cx:pt>
          <cx:pt idx="3">0</cx:pt>
          <cx:pt idx="4">0</cx:pt>
          <cx:pt idx="5">0</cx:pt>
          <cx:pt idx="6">0</cx:pt>
          <cx:pt idx="7">0</cx:pt>
          <cx:pt idx="8">0</cx:pt>
          <cx:pt idx="9">0</cx:pt>
        </cx:lvl>
      </cx:numDim>
    </cx:data>
    <cx:data id="1">
      <cx:numDim type="val">
        <cx:f>[定量化顕微鏡.xlsx]有意さ検定!$S$29:$S$38</cx:f>
        <cx:lvl ptCount="10" formatCode="G/標準">
          <cx:pt idx="0">46</cx:pt>
          <cx:pt idx="1">19</cx:pt>
          <cx:pt idx="2">7</cx:pt>
          <cx:pt idx="3">46</cx:pt>
          <cx:pt idx="4">18</cx:pt>
          <cx:pt idx="5">18</cx:pt>
          <cx:pt idx="6">25</cx:pt>
          <cx:pt idx="7">12</cx:pt>
          <cx:pt idx="8">14</cx:pt>
          <cx:pt idx="9">14</cx:pt>
        </cx:lvl>
      </cx:numDim>
    </cx:data>
    <cx:data id="2">
      <cx:numDim type="val">
        <cx:f>[定量化顕微鏡.xlsx]有意さ検定!$T$29:$T$38</cx:f>
        <cx:lvl ptCount="10" formatCode="G/標準">
          <cx:pt idx="0">2</cx:pt>
          <cx:pt idx="1">2</cx:pt>
          <cx:pt idx="2">1</cx:pt>
          <cx:pt idx="3">14</cx:pt>
          <cx:pt idx="4">12</cx:pt>
          <cx:pt idx="5">17</cx:pt>
          <cx:pt idx="6">1</cx:pt>
          <cx:pt idx="7">2</cx:pt>
          <cx:pt idx="8">6</cx:pt>
          <cx:pt idx="9">3</cx:pt>
        </cx:lvl>
      </cx:numDim>
    </cx:data>
  </cx:chartData>
  <cx:chart>
    <cx:plotArea>
      <cx:plotAreaRegion>
        <cx:series layoutId="boxWhisker" uniqueId="{13EB2AC7-A8D4-4549-9ABF-532270945826}">
          <cx:tx>
            <cx:txData>
              <cx:f>[定量化顕微鏡.xlsx]有意さ検定!$R$28</cx:f>
              <cx:v>cont</cx:v>
            </cx:txData>
          </cx:tx>
          <cx:spPr>
            <a:ln>
              <a:solidFill>
                <a:schemeClr val="tx1"/>
              </a:solidFill>
            </a:ln>
          </cx:spPr>
          <cx:dataId val="0"/>
          <cx:layoutPr>
            <cx:visibility meanLine="1" meanMarker="1" nonoutliers="1" outliers="1"/>
            <cx:statistics quartileMethod="exclusive"/>
          </cx:layoutPr>
        </cx:series>
        <cx:series layoutId="boxWhisker" uniqueId="{A68C62FC-EF74-D342-B893-D95E848E8531}">
          <cx:tx>
            <cx:txData>
              <cx:f>[定量化顕微鏡.xlsx]有意さ検定!$S$28</cx:f>
              <cx:v>nCA</cx:v>
            </cx:txData>
          </cx:tx>
          <cx:spPr>
            <a:solidFill>
              <a:schemeClr val="accent2"/>
            </a:solidFill>
            <a:ln cmpd="sng">
              <a:solidFill>
                <a:schemeClr val="tx1">
                  <a:lumMod val="85000"/>
                  <a:lumOff val="15000"/>
                </a:schemeClr>
              </a:solidFill>
            </a:ln>
          </cx:spPr>
          <cx:dataPt idx="11"/>
          <cx:dataId val="1"/>
          <cx:layoutPr>
            <cx:visibility meanLine="1" meanMarker="1" nonoutliers="1" outliers="1"/>
            <cx:statistics quartileMethod="exclusive"/>
          </cx:layoutPr>
        </cx:series>
        <cx:series layoutId="boxWhisker" uniqueId="{510A9FEB-C759-9249-AD6D-590019B36909}">
          <cx:tx>
            <cx:txData>
              <cx:f>[定量化顕微鏡.xlsx]有意さ検定!$T$28</cx:f>
              <cx:v>PEG-fDAO</cx:v>
            </cx:txData>
          </cx:tx>
          <cx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cx:spPr>
          <cx:dataId val="2"/>
          <cx:layoutPr>
            <cx:visibility meanLine="1" meanMarker="1" nonoutliers="1" outliers="1"/>
            <cx:statistics quartileMethod="exclusive"/>
          </cx:layoutPr>
        </cx:series>
      </cx:plotAreaRegion>
      <cx:axis id="0" hidden="1">
        <cx:catScaling gapWidth="1"/>
        <cx:tickLabels/>
      </cx:axis>
      <cx:axis id="1">
        <cx:valScaling max="60"/>
        <cx:majorGridlines>
          <cx:spPr>
            <a:ln>
              <a:solidFill>
                <a:schemeClr val="tx1">
                  <a:lumMod val="85000"/>
                  <a:lumOff val="15000"/>
                </a:schemeClr>
              </a:solidFill>
            </a:ln>
          </cx:spPr>
        </cx:majorGridlines>
        <cx:tickLabels/>
        <cx:spPr>
          <a:ln>
            <a:solidFill>
              <a:schemeClr val="tx1"/>
            </a:solidFill>
          </a:ln>
        </cx:spPr>
      </cx:axis>
    </cx:plotArea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176D41-51D6-034C-B0B8-2D8A2965DA19}" type="datetimeFigureOut">
              <a:rPr kumimoji="1" lang="ja-JP" altLang="en-US" smtClean="0"/>
              <a:t>2021/11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84F558-8881-1047-BD32-FB7572ED5E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13802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37F3B17-E92A-2948-8338-4EED8BCEEAF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617578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37F3B17-E92A-2948-8338-4EED8BCEEAF4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702638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37F3B17-E92A-2948-8338-4EED8BCEEAF4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19623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8183CD0-A2F1-5141-931C-8CA153449F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D1531AE-6CFA-3A4A-BCD4-C2194E0CDF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CA20776-092F-6F40-9638-90F02FEA1C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04D55-06A9-704B-A255-161853DFC8F7}" type="datetimeFigureOut">
              <a:rPr kumimoji="1" lang="ja-JP" altLang="en-US" smtClean="0"/>
              <a:t>2021/1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B52610A-5B89-EF46-A861-763484FCF3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B178F5E-2F86-6E4C-A39D-779D5F264B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97E6-855A-8A4D-B20C-459CF36486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82655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80FDC5B-36F1-4A4B-9D75-A365C05C83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3C7E6AD-C54C-0B46-A345-15DF7F0631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FD15B32-2009-5F4D-B0D9-8421BC667A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04D55-06A9-704B-A255-161853DFC8F7}" type="datetimeFigureOut">
              <a:rPr kumimoji="1" lang="ja-JP" altLang="en-US" smtClean="0"/>
              <a:t>2021/1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E0778B1-9A6C-AB46-B477-4C21CB63DD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FF1E6BF-F53E-6C46-9DC2-C1A215C22C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97E6-855A-8A4D-B20C-459CF36486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65981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F80305F-4E1A-644E-A7BE-CFDC456720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A8359F1-2208-1D4A-8146-1954697C37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D5ACACD-F024-884F-904B-9A459A359F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04D55-06A9-704B-A255-161853DFC8F7}" type="datetimeFigureOut">
              <a:rPr kumimoji="1" lang="ja-JP" altLang="en-US" smtClean="0"/>
              <a:t>2021/1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C55591-950D-6E47-B5BF-33FF623A78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0496061-FE72-F849-9B1C-C0CC923075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97E6-855A-8A4D-B20C-459CF36486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2860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A17548F-0FB5-6C4C-B462-3C889D021B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69FB650-35D0-9041-899C-CDE91B14F8F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C10688C-37D0-BA48-A52C-686397097F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04D55-06A9-704B-A255-161853DFC8F7}" type="datetimeFigureOut">
              <a:rPr kumimoji="1" lang="ja-JP" altLang="en-US" smtClean="0"/>
              <a:t>2021/1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548FDD5-E511-B94E-A8EA-ACCBA8628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F87C576-3C75-6641-8EA0-E3295B3802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97E6-855A-8A4D-B20C-459CF36486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11846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99057FC-C789-4A42-B1F9-6F775FD397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A65F584-9384-E147-B461-95E6F51628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9228009-DD58-0E4A-BA41-6498135DF6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04D55-06A9-704B-A255-161853DFC8F7}" type="datetimeFigureOut">
              <a:rPr kumimoji="1" lang="ja-JP" altLang="en-US" smtClean="0"/>
              <a:t>2021/1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2D252B0-5840-A440-9FE4-BFD7D60DBD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6B85172-C67D-C94C-83BA-06EA8A9567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97E6-855A-8A4D-B20C-459CF36486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49217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28C06AF-5079-8D40-AE5E-2FE4442AB9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BCD6A92-FEEB-A744-BC79-BFA20B19AA1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F44EDC2-00D1-F24A-B640-2431427316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1886518-60BD-DB4C-A83F-8899FAEE4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04D55-06A9-704B-A255-161853DFC8F7}" type="datetimeFigureOut">
              <a:rPr kumimoji="1" lang="ja-JP" altLang="en-US" smtClean="0"/>
              <a:t>2021/11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7FD9E39-C016-694D-92CC-FFE8FECF68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956AC63-06B6-2648-9FE6-A6483B98C6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97E6-855A-8A4D-B20C-459CF36486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71268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2F330E-3A42-D445-ADC5-89ADC23CE4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F09CD7F-2FD5-114A-A66A-5F82F62D7D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5B579BE-8BE9-0344-B556-43AA3FBF6E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3AC545F-19A2-1042-9B47-4703D58AE3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1A30859-DEAA-5848-AB96-1F091E11F84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DB15DCE-DCB9-E743-93C5-68E4AF406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04D55-06A9-704B-A255-161853DFC8F7}" type="datetimeFigureOut">
              <a:rPr kumimoji="1" lang="ja-JP" altLang="en-US" smtClean="0"/>
              <a:t>2021/11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26D4288-D4E4-734B-869A-7B0204A5E9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938AFDA-CA00-9A4D-9060-19AC7BAF32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97E6-855A-8A4D-B20C-459CF36486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2688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91DE046-6D02-F94F-8A04-6AD6AE5859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FDACB7E-ED51-EC41-A9C3-C183276F48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04D55-06A9-704B-A255-161853DFC8F7}" type="datetimeFigureOut">
              <a:rPr kumimoji="1" lang="ja-JP" altLang="en-US" smtClean="0"/>
              <a:t>2021/11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0C070BC-26C5-7141-858B-9CC242C2AF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26A7D9E-CB3D-1D4A-B30B-FBF52F2536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97E6-855A-8A4D-B20C-459CF36486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1572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3C3BC2D-352A-C640-A5D9-0BF788A13C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04D55-06A9-704B-A255-161853DFC8F7}" type="datetimeFigureOut">
              <a:rPr kumimoji="1" lang="ja-JP" altLang="en-US" smtClean="0"/>
              <a:t>2021/11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13E5A1C-40F2-0D46-92E8-FC1168318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304B8BA-530D-5340-955B-FD2299D3E9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97E6-855A-8A4D-B20C-459CF36486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5731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31C7CD0-538F-8542-95A2-5E02C4203A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5813B15-4C0F-9047-BCA9-2D9E0232072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520312D-8AE3-0147-813C-C2061DA367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BCE7D4F-9B30-0848-954A-D542A622EF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04D55-06A9-704B-A255-161853DFC8F7}" type="datetimeFigureOut">
              <a:rPr kumimoji="1" lang="ja-JP" altLang="en-US" smtClean="0"/>
              <a:t>2021/11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B281227-422D-814C-B46C-91AC487435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317F20B-FF72-0B40-A088-175F083715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97E6-855A-8A4D-B20C-459CF36486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44948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5765238-1DE5-E349-9E6E-F4C716F2BE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1B71D5D-7879-4543-B72F-2DAD271A416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8386AFE-D3CC-DC4C-A9B3-6CABDC2F4D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75F9A10-0694-374A-9F77-6F2EE71FD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04D55-06A9-704B-A255-161853DFC8F7}" type="datetimeFigureOut">
              <a:rPr kumimoji="1" lang="ja-JP" altLang="en-US" smtClean="0"/>
              <a:t>2021/11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E0EC2A8-823C-BE4E-A679-400F884782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AA29428-7A7A-C14F-A49F-A53E9D3B3E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97E6-855A-8A4D-B20C-459CF36486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5202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5B80263-2D1F-9049-B970-040FD8ED6E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5DE0055-DB2E-E045-90C6-EB885BE6FB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4170F5B-A7F8-C44F-81C8-D348B3C82B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E04D55-06A9-704B-A255-161853DFC8F7}" type="datetimeFigureOut">
              <a:rPr kumimoji="1" lang="ja-JP" altLang="en-US" smtClean="0"/>
              <a:t>2021/1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6E9FFC7-500E-AC4A-9150-15B2B265770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0BF0E68-9689-F24C-90E3-37CB2C077E7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4797E6-855A-8A4D-B20C-459CF36486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37345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tiff"/><Relationship Id="rId3" Type="http://schemas.openxmlformats.org/officeDocument/2006/relationships/image" Target="../media/image11.tiff"/><Relationship Id="rId7" Type="http://schemas.openxmlformats.org/officeDocument/2006/relationships/image" Target="../media/image15.tiff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tiff"/><Relationship Id="rId11" Type="http://schemas.openxmlformats.org/officeDocument/2006/relationships/image" Target="../media/image19.tiff"/><Relationship Id="rId5" Type="http://schemas.openxmlformats.org/officeDocument/2006/relationships/image" Target="../media/image13.tiff"/><Relationship Id="rId10" Type="http://schemas.openxmlformats.org/officeDocument/2006/relationships/image" Target="../media/image18.tiff"/><Relationship Id="rId4" Type="http://schemas.openxmlformats.org/officeDocument/2006/relationships/image" Target="../media/image12.tiff"/><Relationship Id="rId9" Type="http://schemas.openxmlformats.org/officeDocument/2006/relationships/image" Target="../media/image17.tiff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14/relationships/chartEx" Target="../charts/chartEx1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microsoft.com/office/2014/relationships/chartEx" Target="../charts/chartEx2.xml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66983D0-7747-3041-AAEC-4E5BD9407C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4267" y="254833"/>
            <a:ext cx="4473493" cy="1025327"/>
          </a:xfrm>
        </p:spPr>
        <p:txBody>
          <a:bodyPr>
            <a:noAutofit/>
          </a:bodyPr>
          <a:lstStyle/>
          <a:p>
            <a:pPr algn="ctr"/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Table 1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表 8">
            <a:extLst>
              <a:ext uri="{FF2B5EF4-FFF2-40B4-BE49-F238E27FC236}">
                <a16:creationId xmlns:a16="http://schemas.microsoft.com/office/drawing/2014/main" id="{9FD7845F-97B4-7949-AF63-9760EF6F1FD7}"/>
              </a:ext>
            </a:extLst>
          </p:cNvPr>
          <p:cNvGraphicFramePr>
            <a:graphicFrameLocks noGrp="1"/>
          </p:cNvGraphicFramePr>
          <p:nvPr/>
        </p:nvGraphicFramePr>
        <p:xfrm>
          <a:off x="2893213" y="1942073"/>
          <a:ext cx="6479387" cy="3168771"/>
        </p:xfrm>
        <a:graphic>
          <a:graphicData uri="http://schemas.openxmlformats.org/drawingml/2006/table">
            <a:tbl>
              <a:tblPr>
                <a:tableStyleId>{2A488322-F2BA-4B5B-9748-0D474271808F}</a:tableStyleId>
              </a:tblPr>
              <a:tblGrid>
                <a:gridCol w="2528255">
                  <a:extLst>
                    <a:ext uri="{9D8B030D-6E8A-4147-A177-3AD203B41FA5}">
                      <a16:colId xmlns:a16="http://schemas.microsoft.com/office/drawing/2014/main" val="121511097"/>
                    </a:ext>
                  </a:extLst>
                </a:gridCol>
                <a:gridCol w="1975566">
                  <a:extLst>
                    <a:ext uri="{9D8B030D-6E8A-4147-A177-3AD203B41FA5}">
                      <a16:colId xmlns:a16="http://schemas.microsoft.com/office/drawing/2014/main" val="223261075"/>
                    </a:ext>
                  </a:extLst>
                </a:gridCol>
                <a:gridCol w="1975566">
                  <a:extLst>
                    <a:ext uri="{9D8B030D-6E8A-4147-A177-3AD203B41FA5}">
                      <a16:colId xmlns:a16="http://schemas.microsoft.com/office/drawing/2014/main" val="3320335939"/>
                    </a:ext>
                  </a:extLst>
                </a:gridCol>
              </a:tblGrid>
              <a:tr h="413863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</a:rPr>
                        <a:t>gnu plot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V</a:t>
                      </a:r>
                      <a:r>
                        <a:rPr lang="en-US" sz="2000" u="none" strike="noStrike" baseline="-25000" dirty="0" err="1">
                          <a:solidFill>
                            <a:schemeClr val="tx1"/>
                          </a:solidFill>
                          <a:effectLst/>
                        </a:rPr>
                        <a:t>max</a:t>
                      </a:r>
                      <a:endParaRPr lang="en-US" sz="2000" b="0" i="0" u="none" strike="noStrike" baseline="-25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V</a:t>
                      </a:r>
                      <a:r>
                        <a:rPr lang="en-US" sz="2000" u="none" strike="noStrike" baseline="-25000" dirty="0" err="1">
                          <a:solidFill>
                            <a:schemeClr val="tx1"/>
                          </a:solidFill>
                          <a:effectLst/>
                        </a:rPr>
                        <a:t>max</a:t>
                      </a:r>
                      <a:endParaRPr lang="en-US" sz="2000" b="0" i="0" u="none" strike="noStrike" baseline="-25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281058604"/>
                  </a:ext>
                </a:extLst>
              </a:tr>
              <a:tr h="41386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at pH 8.2</a:t>
                      </a:r>
                      <a:endParaRPr lang="en-US" sz="2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at pH 6.5</a:t>
                      </a:r>
                      <a:endParaRPr lang="en-US" sz="2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80840102"/>
                  </a:ext>
                </a:extLst>
              </a:tr>
              <a:tr h="4682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</a:rPr>
                        <a:t>D-alanine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2000" u="none" strike="noStrike" dirty="0">
                          <a:effectLst/>
                        </a:rPr>
                        <a:t>29.7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2000" u="none" strike="noStrike" dirty="0">
                          <a:effectLst/>
                        </a:rPr>
                        <a:t>14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147362"/>
                  </a:ext>
                </a:extLst>
              </a:tr>
              <a:tr h="4682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</a:rPr>
                        <a:t>D-proline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2000" u="none" strike="noStrike" dirty="0">
                          <a:effectLst/>
                        </a:rPr>
                        <a:t>17.9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2000" u="none" strike="noStrike" dirty="0">
                          <a:effectLst/>
                        </a:rPr>
                        <a:t>6.4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29431678"/>
                  </a:ext>
                </a:extLst>
              </a:tr>
              <a:tr h="4682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>
                          <a:effectLst/>
                        </a:rPr>
                        <a:t>D-phenyalanine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2000" u="none" strike="noStrike" dirty="0">
                          <a:effectLst/>
                        </a:rPr>
                        <a:t>38.1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2000" u="none" strike="noStrike" dirty="0">
                          <a:effectLst/>
                        </a:rPr>
                        <a:t>18.6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02301997"/>
                  </a:ext>
                </a:extLst>
              </a:tr>
              <a:tr h="4682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>
                          <a:effectLst/>
                        </a:rPr>
                        <a:t>D-methionine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2000" u="none" strike="noStrike" dirty="0">
                          <a:effectLst/>
                        </a:rPr>
                        <a:t>19.8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2000" u="none" strike="noStrike" dirty="0">
                          <a:effectLst/>
                        </a:rPr>
                        <a:t>12.3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70605569"/>
                  </a:ext>
                </a:extLst>
              </a:tr>
              <a:tr h="4682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>
                          <a:effectLst/>
                        </a:rPr>
                        <a:t>D-leucine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2000" u="none" strike="noStrike">
                          <a:effectLst/>
                        </a:rPr>
                        <a:t>15.2</a:t>
                      </a:r>
                      <a:endParaRPr lang="en-US" altLang="ja-JP" sz="2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2000" u="none" strike="noStrike" dirty="0">
                          <a:effectLst/>
                        </a:rPr>
                        <a:t>7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60572311"/>
                  </a:ext>
                </a:extLst>
              </a:tr>
            </a:tbl>
          </a:graphicData>
        </a:graphic>
      </p:graphicFrame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8EC551CA-CE43-E146-BED6-402ABC6C13EF}"/>
              </a:ext>
            </a:extLst>
          </p:cNvPr>
          <p:cNvCxnSpPr>
            <a:cxnSpLocks/>
          </p:cNvCxnSpPr>
          <p:nvPr/>
        </p:nvCxnSpPr>
        <p:spPr>
          <a:xfrm>
            <a:off x="2873831" y="2743200"/>
            <a:ext cx="649876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FBF0F7CD-DB4C-0E43-A974-C1A4D275CACD}"/>
              </a:ext>
            </a:extLst>
          </p:cNvPr>
          <p:cNvCxnSpPr>
            <a:cxnSpLocks/>
          </p:cNvCxnSpPr>
          <p:nvPr/>
        </p:nvCxnSpPr>
        <p:spPr>
          <a:xfrm>
            <a:off x="5448308" y="1921332"/>
            <a:ext cx="0" cy="320583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098354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AF43FC96-4049-454A-8F8F-996B53903501}"/>
              </a:ext>
            </a:extLst>
          </p:cNvPr>
          <p:cNvGrpSpPr>
            <a:grpSpLocks noChangeAspect="1"/>
          </p:cNvGrpSpPr>
          <p:nvPr/>
        </p:nvGrpSpPr>
        <p:grpSpPr>
          <a:xfrm>
            <a:off x="2064317" y="600183"/>
            <a:ext cx="8355251" cy="6127810"/>
            <a:chOff x="-51879" y="0"/>
            <a:chExt cx="9358192" cy="6863379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DCCB153A-C17A-A94E-9E1C-7D5D9ADE47F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83" y="0"/>
              <a:ext cx="9144000" cy="6858000"/>
            </a:xfrm>
            <a:prstGeom prst="rect">
              <a:avLst/>
            </a:prstGeom>
          </p:spPr>
        </p:pic>
        <p:cxnSp>
          <p:nvCxnSpPr>
            <p:cNvPr id="5" name="直線コネクタ 4">
              <a:extLst>
                <a:ext uri="{FF2B5EF4-FFF2-40B4-BE49-F238E27FC236}">
                  <a16:creationId xmlns:a16="http://schemas.microsoft.com/office/drawing/2014/main" id="{14A9B304-29D0-B444-A21E-A034F0D8C2CF}"/>
                </a:ext>
              </a:extLst>
            </p:cNvPr>
            <p:cNvCxnSpPr/>
            <p:nvPr/>
          </p:nvCxnSpPr>
          <p:spPr>
            <a:xfrm>
              <a:off x="3603812" y="0"/>
              <a:ext cx="21515" cy="686337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50F17A73-40ED-924A-A205-13D759989AA6}"/>
                </a:ext>
              </a:extLst>
            </p:cNvPr>
            <p:cNvCxnSpPr/>
            <p:nvPr/>
          </p:nvCxnSpPr>
          <p:spPr>
            <a:xfrm>
              <a:off x="7048052" y="0"/>
              <a:ext cx="21515" cy="686337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CE78DC3A-7529-864F-8C19-45F9AB4B6622}"/>
                </a:ext>
              </a:extLst>
            </p:cNvPr>
            <p:cNvSpPr/>
            <p:nvPr/>
          </p:nvSpPr>
          <p:spPr>
            <a:xfrm>
              <a:off x="3063204" y="6137514"/>
              <a:ext cx="4356561" cy="586026"/>
            </a:xfrm>
            <a:prstGeom prst="rect">
              <a:avLst/>
            </a:prstGeom>
            <a:noFill/>
          </p:spPr>
          <p:txBody>
            <a:bodyPr wrap="square" lIns="91440" tIns="45720" rIns="91440" bIns="45720">
              <a:spAutoFit/>
            </a:bodyPr>
            <a:lstStyle/>
            <a:p>
              <a:pPr algn="ctr"/>
              <a:r>
                <a:rPr lang="en-US" altLang="ja-JP" sz="2800" b="1" dirty="0">
                  <a:ln w="0"/>
                  <a:effectLst>
                    <a:outerShdw blurRad="38100" dist="25400" dir="5400000" algn="ctr" rotWithShape="0">
                      <a:srgbClr val="6E747A">
                        <a:alpha val="43000"/>
                      </a:srgb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PEG-</a:t>
              </a:r>
              <a:r>
                <a:rPr lang="en-US" altLang="ja-JP" sz="2800" b="1" dirty="0" err="1">
                  <a:ln w="0"/>
                  <a:effectLst>
                    <a:outerShdw blurRad="38100" dist="25400" dir="5400000" algn="ctr" rotWithShape="0">
                      <a:srgbClr val="6E747A">
                        <a:alpha val="43000"/>
                      </a:srgb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fDAO</a:t>
              </a:r>
              <a:r>
                <a:rPr lang="en-US" altLang="ja-JP" sz="2800" b="1" dirty="0">
                  <a:ln w="0"/>
                  <a:effectLst>
                    <a:outerShdw blurRad="38100" dist="25400" dir="5400000" algn="ctr" rotWithShape="0">
                      <a:srgbClr val="6E747A">
                        <a:alpha val="43000"/>
                      </a:srgb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/Day 8</a:t>
              </a:r>
              <a:endParaRPr lang="ja-JP" altLang="en-US" sz="2800" b="1" dirty="0">
                <a:ln w="0"/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4DF408D5-053D-5B4F-A264-4B05D0D85933}"/>
                </a:ext>
              </a:extLst>
            </p:cNvPr>
            <p:cNvSpPr/>
            <p:nvPr/>
          </p:nvSpPr>
          <p:spPr>
            <a:xfrm>
              <a:off x="-51879" y="6137514"/>
              <a:ext cx="3420001" cy="586026"/>
            </a:xfrm>
            <a:prstGeom prst="rect">
              <a:avLst/>
            </a:prstGeom>
            <a:noFill/>
          </p:spPr>
          <p:txBody>
            <a:bodyPr wrap="square" lIns="91440" tIns="45720" rIns="91440" bIns="45720">
              <a:spAutoFit/>
            </a:bodyPr>
            <a:lstStyle/>
            <a:p>
              <a:pPr algn="ctr"/>
              <a:r>
                <a:rPr lang="en-US" altLang="ja-JP" sz="2800" b="1" dirty="0" err="1">
                  <a:ln w="0"/>
                  <a:effectLst>
                    <a:outerShdw blurRad="38100" dist="25400" dir="5400000" algn="ctr" rotWithShape="0">
                      <a:srgbClr val="6E747A">
                        <a:alpha val="43000"/>
                      </a:srgb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nCA</a:t>
              </a:r>
              <a:r>
                <a:rPr lang="en-US" altLang="ja-JP" sz="2800" b="1" dirty="0">
                  <a:ln w="0"/>
                  <a:effectLst>
                    <a:outerShdw blurRad="38100" dist="25400" dir="5400000" algn="ctr" rotWithShape="0">
                      <a:srgbClr val="6E747A">
                        <a:alpha val="43000"/>
                      </a:srgb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/Day 8</a:t>
              </a:r>
              <a:endParaRPr lang="ja-JP" altLang="en-US" sz="2800" b="1" dirty="0">
                <a:ln w="0"/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F5F6EA77-070D-184C-8F70-21443B395589}"/>
                </a:ext>
              </a:extLst>
            </p:cNvPr>
            <p:cNvSpPr/>
            <p:nvPr/>
          </p:nvSpPr>
          <p:spPr>
            <a:xfrm>
              <a:off x="6915701" y="6137514"/>
              <a:ext cx="2390612" cy="603716"/>
            </a:xfrm>
            <a:prstGeom prst="rect">
              <a:avLst/>
            </a:prstGeom>
            <a:noFill/>
          </p:spPr>
          <p:txBody>
            <a:bodyPr wrap="square" lIns="91440" tIns="45720" rIns="91440" bIns="45720">
              <a:spAutoFit/>
            </a:bodyPr>
            <a:lstStyle/>
            <a:p>
              <a:pPr algn="ctr"/>
              <a:r>
                <a:rPr lang="en-US" altLang="ja-JP" sz="2800" b="1" dirty="0" err="1">
                  <a:ln w="0"/>
                  <a:effectLst>
                    <a:outerShdw blurRad="38100" dist="25400" dir="5400000" algn="ctr" rotWithShape="0">
                      <a:srgbClr val="6E747A">
                        <a:alpha val="43000"/>
                      </a:srgb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nCA</a:t>
              </a:r>
              <a:r>
                <a:rPr lang="en-US" altLang="ja-JP" sz="2800" b="1" dirty="0">
                  <a:ln w="0"/>
                  <a:effectLst>
                    <a:outerShdw blurRad="38100" dist="25400" dir="5400000" algn="ctr" rotWithShape="0">
                      <a:srgbClr val="6E747A">
                        <a:alpha val="43000"/>
                      </a:srgb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/Day 2</a:t>
              </a:r>
              <a:endParaRPr lang="ja-JP" altLang="en-US" sz="2800" b="1" dirty="0">
                <a:ln w="0"/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613A1E8D-3144-4644-837F-08191C5ED8DF}"/>
              </a:ext>
            </a:extLst>
          </p:cNvPr>
          <p:cNvSpPr/>
          <p:nvPr/>
        </p:nvSpPr>
        <p:spPr>
          <a:xfrm>
            <a:off x="129092" y="172121"/>
            <a:ext cx="11184745" cy="91440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6429CCD-61AE-8141-80B3-235F8855B508}"/>
              </a:ext>
            </a:extLst>
          </p:cNvPr>
          <p:cNvSpPr txBox="1"/>
          <p:nvPr/>
        </p:nvSpPr>
        <p:spPr>
          <a:xfrm>
            <a:off x="202154" y="215143"/>
            <a:ext cx="4423634" cy="59168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tabLst>
                <a:tab pos="1193800" algn="l"/>
              </a:tabLst>
            </a:pPr>
            <a:r>
              <a:rPr kumimoji="1"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</a:t>
            </a:r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</a:t>
            </a:r>
          </a:p>
        </p:txBody>
      </p:sp>
    </p:spTree>
    <p:extLst>
      <p:ext uri="{BB962C8B-B14F-4D97-AF65-F5344CB8AC3E}">
        <p14:creationId xmlns:p14="http://schemas.microsoft.com/office/powerpoint/2010/main" val="14542267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ECE2B52B-7851-3947-A515-083D4D01DCB0}"/>
              </a:ext>
            </a:extLst>
          </p:cNvPr>
          <p:cNvCxnSpPr>
            <a:cxnSpLocks/>
          </p:cNvCxnSpPr>
          <p:nvPr/>
        </p:nvCxnSpPr>
        <p:spPr>
          <a:xfrm>
            <a:off x="8037458" y="4315472"/>
            <a:ext cx="0" cy="798076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3C54F2C3-3F05-E44E-AE5B-71E7DEAD72B2}"/>
              </a:ext>
            </a:extLst>
          </p:cNvPr>
          <p:cNvCxnSpPr>
            <a:cxnSpLocks/>
          </p:cNvCxnSpPr>
          <p:nvPr/>
        </p:nvCxnSpPr>
        <p:spPr>
          <a:xfrm>
            <a:off x="9307458" y="1965972"/>
            <a:ext cx="0" cy="190500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17F086C6-31DF-104B-9080-347810ADE485}"/>
              </a:ext>
            </a:extLst>
          </p:cNvPr>
          <p:cNvCxnSpPr>
            <a:cxnSpLocks/>
          </p:cNvCxnSpPr>
          <p:nvPr/>
        </p:nvCxnSpPr>
        <p:spPr>
          <a:xfrm>
            <a:off x="10577458" y="3502672"/>
            <a:ext cx="0" cy="170180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61" name="グラフ 60">
            <a:extLst>
              <a:ext uri="{FF2B5EF4-FFF2-40B4-BE49-F238E27FC236}">
                <a16:creationId xmlns:a16="http://schemas.microsoft.com/office/drawing/2014/main" id="{148A8A01-EC37-B54D-B18B-493D9E8B7A7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4538468"/>
              </p:ext>
            </p:extLst>
          </p:nvPr>
        </p:nvGraphicFramePr>
        <p:xfrm>
          <a:off x="6769032" y="1303032"/>
          <a:ext cx="4572000" cy="48780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8A38CC7-436E-4349-8C47-628D94750F3C}"/>
              </a:ext>
            </a:extLst>
          </p:cNvPr>
          <p:cNvSpPr txBox="1"/>
          <p:nvPr/>
        </p:nvSpPr>
        <p:spPr>
          <a:xfrm>
            <a:off x="1005636" y="2231190"/>
            <a:ext cx="966931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kumimoji="1" lang="ja-JP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71D01A8-30BE-924F-97C3-C9B05F9C0F05}"/>
              </a:ext>
            </a:extLst>
          </p:cNvPr>
          <p:cNvSpPr txBox="1"/>
          <p:nvPr/>
        </p:nvSpPr>
        <p:spPr>
          <a:xfrm>
            <a:off x="1103432" y="3699200"/>
            <a:ext cx="670376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A</a:t>
            </a:r>
            <a:endParaRPr kumimoji="1" lang="ja-JP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E9AB260-F922-A443-A642-7AE1FBED9CF7}"/>
              </a:ext>
            </a:extLst>
          </p:cNvPr>
          <p:cNvSpPr txBox="1"/>
          <p:nvPr/>
        </p:nvSpPr>
        <p:spPr>
          <a:xfrm>
            <a:off x="420827" y="5091454"/>
            <a:ext cx="154320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G-</a:t>
            </a:r>
            <a:r>
              <a:rPr lang="en-US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DAO</a:t>
            </a:r>
            <a:endParaRPr lang="en-US" altLang="ja-JP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6777CDEF-65E8-0347-A7DD-89AE23A166E0}"/>
              </a:ext>
            </a:extLst>
          </p:cNvPr>
          <p:cNvCxnSpPr>
            <a:cxnSpLocks/>
          </p:cNvCxnSpPr>
          <p:nvPr/>
        </p:nvCxnSpPr>
        <p:spPr>
          <a:xfrm>
            <a:off x="21713266" y="-1893367"/>
            <a:ext cx="0" cy="4581833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10798783-48A6-A643-A9E2-49BEBF6F9A90}"/>
              </a:ext>
            </a:extLst>
          </p:cNvPr>
          <p:cNvCxnSpPr>
            <a:cxnSpLocks/>
          </p:cNvCxnSpPr>
          <p:nvPr/>
        </p:nvCxnSpPr>
        <p:spPr>
          <a:xfrm>
            <a:off x="8872269" y="2289385"/>
            <a:ext cx="0" cy="4581833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646AEC95-3C42-AA47-AEC3-04EE9ED67CF5}"/>
              </a:ext>
            </a:extLst>
          </p:cNvPr>
          <p:cNvGrpSpPr/>
          <p:nvPr/>
        </p:nvGrpSpPr>
        <p:grpSpPr>
          <a:xfrm>
            <a:off x="2029844" y="1613039"/>
            <a:ext cx="3976503" cy="4357453"/>
            <a:chOff x="1958132" y="1828188"/>
            <a:chExt cx="3090470" cy="3595458"/>
          </a:xfrm>
        </p:grpSpPr>
        <p:sp>
          <p:nvSpPr>
            <p:cNvPr id="50" name="正方形/長方形 49">
              <a:extLst>
                <a:ext uri="{FF2B5EF4-FFF2-40B4-BE49-F238E27FC236}">
                  <a16:creationId xmlns:a16="http://schemas.microsoft.com/office/drawing/2014/main" id="{427DC142-79E0-784F-8038-C33468CE7D09}"/>
                </a:ext>
              </a:extLst>
            </p:cNvPr>
            <p:cNvSpPr/>
            <p:nvPr/>
          </p:nvSpPr>
          <p:spPr>
            <a:xfrm>
              <a:off x="1962574" y="1836384"/>
              <a:ext cx="3083170" cy="3587262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A2BAE9B1-30B7-F84F-9A0C-B1A7E8A0E98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58132" y="1828188"/>
              <a:ext cx="1041400" cy="1231900"/>
            </a:xfrm>
            <a:prstGeom prst="rect">
              <a:avLst/>
            </a:prstGeom>
          </p:spPr>
        </p:pic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07944719-97FC-1747-AF57-D063BB9979B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994259" y="1828188"/>
              <a:ext cx="1041400" cy="1231900"/>
            </a:xfrm>
            <a:prstGeom prst="rect">
              <a:avLst/>
            </a:prstGeom>
          </p:spPr>
        </p:pic>
        <p:pic>
          <p:nvPicPr>
            <p:cNvPr id="11" name="図 10">
              <a:extLst>
                <a:ext uri="{FF2B5EF4-FFF2-40B4-BE49-F238E27FC236}">
                  <a16:creationId xmlns:a16="http://schemas.microsoft.com/office/drawing/2014/main" id="{C6EE2E8B-924F-DE4B-AB0B-E3F6C8809EE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994502" y="1828188"/>
              <a:ext cx="1054100" cy="1231900"/>
            </a:xfrm>
            <a:prstGeom prst="rect">
              <a:avLst/>
            </a:prstGeom>
          </p:spPr>
        </p:pic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D3DEBF63-853F-7547-9DA2-85F982996E5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958132" y="3074871"/>
              <a:ext cx="1092200" cy="1168400"/>
            </a:xfrm>
            <a:prstGeom prst="rect">
              <a:avLst/>
            </a:prstGeom>
          </p:spPr>
        </p:pic>
        <p:pic>
          <p:nvPicPr>
            <p:cNvPr id="16" name="図 15">
              <a:extLst>
                <a:ext uri="{FF2B5EF4-FFF2-40B4-BE49-F238E27FC236}">
                  <a16:creationId xmlns:a16="http://schemas.microsoft.com/office/drawing/2014/main" id="{1B2856A0-2741-9B4D-B99C-F3D4F9F39FB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994259" y="3074871"/>
              <a:ext cx="1041400" cy="1231900"/>
            </a:xfrm>
            <a:prstGeom prst="rect">
              <a:avLst/>
            </a:prstGeom>
          </p:spPr>
        </p:pic>
        <p:pic>
          <p:nvPicPr>
            <p:cNvPr id="17" name="図 16">
              <a:extLst>
                <a:ext uri="{FF2B5EF4-FFF2-40B4-BE49-F238E27FC236}">
                  <a16:creationId xmlns:a16="http://schemas.microsoft.com/office/drawing/2014/main" id="{FA90B302-89BF-8847-AE58-9FDB81C3951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994502" y="3074871"/>
              <a:ext cx="1054100" cy="1206500"/>
            </a:xfrm>
            <a:prstGeom prst="rect">
              <a:avLst/>
            </a:prstGeom>
          </p:spPr>
        </p:pic>
        <p:pic>
          <p:nvPicPr>
            <p:cNvPr id="19" name="図 18">
              <a:extLst>
                <a:ext uri="{FF2B5EF4-FFF2-40B4-BE49-F238E27FC236}">
                  <a16:creationId xmlns:a16="http://schemas.microsoft.com/office/drawing/2014/main" id="{33B96EB6-5B79-664E-B603-9F0123E0684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974461" y="4285852"/>
              <a:ext cx="1054100" cy="1130300"/>
            </a:xfrm>
            <a:prstGeom prst="rect">
              <a:avLst/>
            </a:prstGeom>
          </p:spPr>
        </p:pic>
        <p:pic>
          <p:nvPicPr>
            <p:cNvPr id="20" name="図 19">
              <a:extLst>
                <a:ext uri="{FF2B5EF4-FFF2-40B4-BE49-F238E27FC236}">
                  <a16:creationId xmlns:a16="http://schemas.microsoft.com/office/drawing/2014/main" id="{0DCA92FE-8CB7-8B4D-B22C-746A02ABCF8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010588" y="4240495"/>
              <a:ext cx="1041400" cy="1143000"/>
            </a:xfrm>
            <a:prstGeom prst="rect">
              <a:avLst/>
            </a:prstGeom>
          </p:spPr>
        </p:pic>
        <p:pic>
          <p:nvPicPr>
            <p:cNvPr id="21" name="図 20">
              <a:extLst>
                <a:ext uri="{FF2B5EF4-FFF2-40B4-BE49-F238E27FC236}">
                  <a16:creationId xmlns:a16="http://schemas.microsoft.com/office/drawing/2014/main" id="{D3DCA4DD-A727-BC47-B51C-5F6B7103755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041394" y="4336652"/>
              <a:ext cx="1003300" cy="1079500"/>
            </a:xfrm>
            <a:prstGeom prst="rect">
              <a:avLst/>
            </a:prstGeom>
          </p:spPr>
        </p:pic>
      </p:grp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F63383F0-2095-B546-904A-91036DC169D6}"/>
              </a:ext>
            </a:extLst>
          </p:cNvPr>
          <p:cNvSpPr txBox="1"/>
          <p:nvPr/>
        </p:nvSpPr>
        <p:spPr>
          <a:xfrm>
            <a:off x="7462395" y="1595792"/>
            <a:ext cx="9492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21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3FF95088-921B-0A44-A2CA-AD22034EF91B}"/>
              </a:ext>
            </a:extLst>
          </p:cNvPr>
          <p:cNvSpPr txBox="1"/>
          <p:nvPr/>
        </p:nvSpPr>
        <p:spPr>
          <a:xfrm>
            <a:off x="9923102" y="1578707"/>
            <a:ext cx="9492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62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641DE3F1-D9B6-9744-BD21-757C38378A23}"/>
              </a:ext>
            </a:extLst>
          </p:cNvPr>
          <p:cNvCxnSpPr>
            <a:cxnSpLocks/>
          </p:cNvCxnSpPr>
          <p:nvPr/>
        </p:nvCxnSpPr>
        <p:spPr>
          <a:xfrm flipH="1">
            <a:off x="7991548" y="1986640"/>
            <a:ext cx="1" cy="138522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7AB894EF-521B-6141-A284-89A98D02BF6E}"/>
              </a:ext>
            </a:extLst>
          </p:cNvPr>
          <p:cNvCxnSpPr>
            <a:cxnSpLocks/>
          </p:cNvCxnSpPr>
          <p:nvPr/>
        </p:nvCxnSpPr>
        <p:spPr>
          <a:xfrm>
            <a:off x="10556982" y="1977402"/>
            <a:ext cx="0" cy="139446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9C24B714-5831-0541-9587-7BF58AD41B13}"/>
              </a:ext>
            </a:extLst>
          </p:cNvPr>
          <p:cNvCxnSpPr>
            <a:cxnSpLocks/>
          </p:cNvCxnSpPr>
          <p:nvPr/>
        </p:nvCxnSpPr>
        <p:spPr>
          <a:xfrm>
            <a:off x="9309086" y="1764005"/>
            <a:ext cx="0" cy="124209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A156871D-4034-234C-8947-872855D25139}"/>
              </a:ext>
            </a:extLst>
          </p:cNvPr>
          <p:cNvCxnSpPr>
            <a:cxnSpLocks/>
            <a:stCxn id="76" idx="1"/>
          </p:cNvCxnSpPr>
          <p:nvPr/>
        </p:nvCxnSpPr>
        <p:spPr>
          <a:xfrm flipH="1">
            <a:off x="8468876" y="1763373"/>
            <a:ext cx="1454226" cy="78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1006521-C60A-5F4B-A116-FDE83E0DDE2E}"/>
              </a:ext>
            </a:extLst>
          </p:cNvPr>
          <p:cNvSpPr txBox="1"/>
          <p:nvPr/>
        </p:nvSpPr>
        <p:spPr>
          <a:xfrm>
            <a:off x="7632346" y="6126433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79EE60B-B0A0-DA4F-A2FC-E598C7335CEF}"/>
              </a:ext>
            </a:extLst>
          </p:cNvPr>
          <p:cNvSpPr txBox="1"/>
          <p:nvPr/>
        </p:nvSpPr>
        <p:spPr>
          <a:xfrm>
            <a:off x="8993858" y="6126433"/>
            <a:ext cx="625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A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04D7BD0-250D-634D-9086-DFE9633C4A48}"/>
              </a:ext>
            </a:extLst>
          </p:cNvPr>
          <p:cNvSpPr txBox="1"/>
          <p:nvPr/>
        </p:nvSpPr>
        <p:spPr>
          <a:xfrm>
            <a:off x="9931544" y="6126433"/>
            <a:ext cx="1317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G-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DAO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4D86C7A-55E8-1742-B3B3-9D4496EF2AB5}"/>
              </a:ext>
            </a:extLst>
          </p:cNvPr>
          <p:cNvSpPr txBox="1"/>
          <p:nvPr/>
        </p:nvSpPr>
        <p:spPr>
          <a:xfrm>
            <a:off x="389208" y="322161"/>
            <a:ext cx="394749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2 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644DE85-D55F-204C-8044-2F3C2765E0C0}"/>
              </a:ext>
            </a:extLst>
          </p:cNvPr>
          <p:cNvSpPr txBox="1"/>
          <p:nvPr/>
        </p:nvSpPr>
        <p:spPr>
          <a:xfrm>
            <a:off x="9154092" y="1771662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x</a:t>
            </a:r>
            <a:endParaRPr kumimoji="1" lang="ja-JP" altLang="en-US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A46549F9-BA2B-144F-9FD2-3ACC5B2BE179}"/>
              </a:ext>
            </a:extLst>
          </p:cNvPr>
          <p:cNvSpPr txBox="1"/>
          <p:nvPr/>
        </p:nvSpPr>
        <p:spPr>
          <a:xfrm>
            <a:off x="9169332" y="3329952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x</a:t>
            </a:r>
            <a:endParaRPr kumimoji="1" lang="ja-JP" altLang="en-US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B437F41E-7A87-4547-83F9-01497E71D82A}"/>
              </a:ext>
            </a:extLst>
          </p:cNvPr>
          <p:cNvSpPr txBox="1"/>
          <p:nvPr/>
        </p:nvSpPr>
        <p:spPr>
          <a:xfrm>
            <a:off x="9264582" y="3322332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x</a:t>
            </a:r>
            <a:endParaRPr kumimoji="1" lang="ja-JP" altLang="en-US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37EF403E-1A52-0D46-A835-514B2B21A264}"/>
              </a:ext>
            </a:extLst>
          </p:cNvPr>
          <p:cNvSpPr txBox="1"/>
          <p:nvPr/>
        </p:nvSpPr>
        <p:spPr>
          <a:xfrm>
            <a:off x="10422822" y="3634752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x</a:t>
            </a:r>
            <a:endParaRPr kumimoji="1" lang="ja-JP" altLang="en-US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2F492592-2B8D-1142-A561-A6BBBC51F948}"/>
              </a:ext>
            </a:extLst>
          </p:cNvPr>
          <p:cNvSpPr txBox="1"/>
          <p:nvPr/>
        </p:nvSpPr>
        <p:spPr>
          <a:xfrm>
            <a:off x="10426632" y="3855732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x</a:t>
            </a:r>
            <a:endParaRPr kumimoji="1" lang="ja-JP" altLang="en-US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E9F0385A-6C2D-6140-8469-FC3161487C2A}"/>
              </a:ext>
            </a:extLst>
          </p:cNvPr>
          <p:cNvSpPr txBox="1"/>
          <p:nvPr/>
        </p:nvSpPr>
        <p:spPr>
          <a:xfrm>
            <a:off x="10430442" y="5173992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x</a:t>
            </a:r>
            <a:endParaRPr kumimoji="1" lang="ja-JP" altLang="en-US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48015543-B851-0C49-BA0F-D1DD53A8A441}"/>
              </a:ext>
            </a:extLst>
          </p:cNvPr>
          <p:cNvSpPr txBox="1"/>
          <p:nvPr/>
        </p:nvSpPr>
        <p:spPr>
          <a:xfrm>
            <a:off x="7896792" y="4171962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x</a:t>
            </a:r>
            <a:endParaRPr kumimoji="1" lang="ja-JP" altLang="en-US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D2B99D4B-93CA-7240-B141-364B487EA827}"/>
              </a:ext>
            </a:extLst>
          </p:cNvPr>
          <p:cNvSpPr txBox="1"/>
          <p:nvPr/>
        </p:nvSpPr>
        <p:spPr>
          <a:xfrm>
            <a:off x="7900602" y="4358652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x</a:t>
            </a:r>
            <a:endParaRPr kumimoji="1" lang="ja-JP" altLang="en-US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3A6E024F-A60D-4C46-AA19-7FFB671BDEF9}"/>
              </a:ext>
            </a:extLst>
          </p:cNvPr>
          <p:cNvSpPr txBox="1"/>
          <p:nvPr/>
        </p:nvSpPr>
        <p:spPr>
          <a:xfrm>
            <a:off x="7892982" y="4979682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x</a:t>
            </a:r>
            <a:endParaRPr kumimoji="1" lang="ja-JP" altLang="en-US"/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0BF11132-93C2-B04B-A780-57DB1A087C89}"/>
              </a:ext>
            </a:extLst>
          </p:cNvPr>
          <p:cNvCxnSpPr>
            <a:cxnSpLocks/>
          </p:cNvCxnSpPr>
          <p:nvPr/>
        </p:nvCxnSpPr>
        <p:spPr>
          <a:xfrm>
            <a:off x="10354242" y="4389132"/>
            <a:ext cx="411480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A56E5D02-3DEF-1843-ACF0-10049B8DCEF6}"/>
              </a:ext>
            </a:extLst>
          </p:cNvPr>
          <p:cNvCxnSpPr>
            <a:cxnSpLocks/>
          </p:cNvCxnSpPr>
          <p:nvPr/>
        </p:nvCxnSpPr>
        <p:spPr>
          <a:xfrm>
            <a:off x="9100752" y="2975622"/>
            <a:ext cx="411480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7238941E-A03D-9B4A-9DDD-C6EB253EB85C}"/>
              </a:ext>
            </a:extLst>
          </p:cNvPr>
          <p:cNvCxnSpPr>
            <a:cxnSpLocks/>
          </p:cNvCxnSpPr>
          <p:nvPr/>
        </p:nvCxnSpPr>
        <p:spPr>
          <a:xfrm>
            <a:off x="7824402" y="4671072"/>
            <a:ext cx="411480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50CD401-0258-174E-85D4-3659C28A7747}"/>
              </a:ext>
            </a:extLst>
          </p:cNvPr>
          <p:cNvSpPr txBox="1"/>
          <p:nvPr/>
        </p:nvSpPr>
        <p:spPr>
          <a:xfrm>
            <a:off x="6282467" y="1032727"/>
            <a:ext cx="1133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ton Volume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12933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B9CDDA1F-A602-744B-9D86-D0D328CEFBA8}"/>
              </a:ext>
            </a:extLst>
          </p:cNvPr>
          <p:cNvCxnSpPr>
            <a:cxnSpLocks/>
          </p:cNvCxnSpPr>
          <p:nvPr/>
        </p:nvCxnSpPr>
        <p:spPr>
          <a:xfrm>
            <a:off x="10467876" y="4880286"/>
            <a:ext cx="411480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EDB17093-797A-D241-9851-16E7A20B1A7E}"/>
              </a:ext>
            </a:extLst>
          </p:cNvPr>
          <p:cNvCxnSpPr>
            <a:cxnSpLocks/>
          </p:cNvCxnSpPr>
          <p:nvPr/>
        </p:nvCxnSpPr>
        <p:spPr>
          <a:xfrm>
            <a:off x="9214386" y="2849556"/>
            <a:ext cx="411480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4BE2535A-9F3C-0545-B2DF-7EEF6EB68D30}"/>
              </a:ext>
            </a:extLst>
          </p:cNvPr>
          <p:cNvCxnSpPr>
            <a:cxnSpLocks/>
          </p:cNvCxnSpPr>
          <p:nvPr/>
        </p:nvCxnSpPr>
        <p:spPr>
          <a:xfrm>
            <a:off x="7915176" y="4990776"/>
            <a:ext cx="411480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3" name="グラフ 52">
            <a:extLst>
              <a:ext uri="{FF2B5EF4-FFF2-40B4-BE49-F238E27FC236}">
                <a16:creationId xmlns:a16="http://schemas.microsoft.com/office/drawing/2014/main" id="{79C91C60-928D-4140-857C-41010AB8FDB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37232929"/>
              </p:ext>
            </p:extLst>
          </p:nvPr>
        </p:nvGraphicFramePr>
        <p:xfrm>
          <a:off x="6871236" y="1428426"/>
          <a:ext cx="4572000" cy="46748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6777CDEF-65E8-0347-A7DD-89AE23A166E0}"/>
              </a:ext>
            </a:extLst>
          </p:cNvPr>
          <p:cNvCxnSpPr>
            <a:cxnSpLocks/>
          </p:cNvCxnSpPr>
          <p:nvPr/>
        </p:nvCxnSpPr>
        <p:spPr>
          <a:xfrm>
            <a:off x="21713266" y="-1893367"/>
            <a:ext cx="0" cy="4581833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9D8A4D27-C99F-234E-A85B-72DB861F12F1}"/>
              </a:ext>
            </a:extLst>
          </p:cNvPr>
          <p:cNvSpPr txBox="1"/>
          <p:nvPr/>
        </p:nvSpPr>
        <p:spPr>
          <a:xfrm>
            <a:off x="348960" y="279699"/>
            <a:ext cx="384489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3</a:t>
            </a: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A3D2251B-5B68-724F-8516-0E39AB6087AC}"/>
              </a:ext>
            </a:extLst>
          </p:cNvPr>
          <p:cNvSpPr/>
          <p:nvPr/>
        </p:nvSpPr>
        <p:spPr>
          <a:xfrm>
            <a:off x="1810872" y="1308847"/>
            <a:ext cx="4285128" cy="444649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24" name="図 23">
            <a:extLst>
              <a:ext uri="{FF2B5EF4-FFF2-40B4-BE49-F238E27FC236}">
                <a16:creationId xmlns:a16="http://schemas.microsoft.com/office/drawing/2014/main" id="{FC5AD0F5-2B97-2648-A311-69BC6FAF7E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1922079" y="1311826"/>
            <a:ext cx="1310897" cy="1471287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03DA13D4-6B7A-BD40-B4C4-4F160ECC5B4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400000">
            <a:off x="3314665" y="1311826"/>
            <a:ext cx="1259151" cy="1489013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D130FF4C-E13D-0842-90DC-87E58CFEC9B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5400000">
            <a:off x="4660951" y="1311826"/>
            <a:ext cx="1293648" cy="1471287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EC3D49D3-839E-604A-BA62-221E5E55DC0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16025634">
            <a:off x="1922079" y="2874309"/>
            <a:ext cx="1328146" cy="1329476"/>
          </a:xfrm>
          <a:prstGeom prst="rect">
            <a:avLst/>
          </a:prstGeom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id="{86BC3A5B-AA5C-BE44-884C-F39B878A4F0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16427969">
            <a:off x="3314665" y="2889686"/>
            <a:ext cx="1345394" cy="1329476"/>
          </a:xfrm>
          <a:prstGeom prst="rect">
            <a:avLst/>
          </a:prstGeom>
        </p:spPr>
      </p:pic>
      <p:pic>
        <p:nvPicPr>
          <p:cNvPr id="36" name="図 35">
            <a:extLst>
              <a:ext uri="{FF2B5EF4-FFF2-40B4-BE49-F238E27FC236}">
                <a16:creationId xmlns:a16="http://schemas.microsoft.com/office/drawing/2014/main" id="{B4257880-83BD-EE4E-B6FA-0F1BE95C03A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16200000">
            <a:off x="4643022" y="2905063"/>
            <a:ext cx="1345394" cy="1329476"/>
          </a:xfrm>
          <a:prstGeom prst="rect">
            <a:avLst/>
          </a:prstGeom>
        </p:spPr>
      </p:pic>
      <p:pic>
        <p:nvPicPr>
          <p:cNvPr id="38" name="図 37">
            <a:extLst>
              <a:ext uri="{FF2B5EF4-FFF2-40B4-BE49-F238E27FC236}">
                <a16:creationId xmlns:a16="http://schemas.microsoft.com/office/drawing/2014/main" id="{8025CC71-DE4F-1848-9599-CBB51C179BB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rot="5400000">
            <a:off x="1922079" y="4336216"/>
            <a:ext cx="1345394" cy="1329476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id="{9B2F7610-5C19-4D45-8F2A-D2C12A67E8E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rot="5400000">
            <a:off x="3314665" y="4336216"/>
            <a:ext cx="1328146" cy="1329476"/>
          </a:xfrm>
          <a:prstGeom prst="rect">
            <a:avLst/>
          </a:prstGeom>
        </p:spPr>
      </p:pic>
      <p:pic>
        <p:nvPicPr>
          <p:cNvPr id="47" name="図 46">
            <a:extLst>
              <a:ext uri="{FF2B5EF4-FFF2-40B4-BE49-F238E27FC236}">
                <a16:creationId xmlns:a16="http://schemas.microsoft.com/office/drawing/2014/main" id="{B8BC2A22-026C-5A4F-8FE9-9189BC041AD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rot="5400000">
            <a:off x="4660951" y="4371669"/>
            <a:ext cx="1328146" cy="1294023"/>
          </a:xfrm>
          <a:prstGeom prst="rect">
            <a:avLst/>
          </a:prstGeom>
        </p:spPr>
      </p:pic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F23BA170-CD79-4945-B7A5-831DFFF68763}"/>
              </a:ext>
            </a:extLst>
          </p:cNvPr>
          <p:cNvSpPr txBox="1"/>
          <p:nvPr/>
        </p:nvSpPr>
        <p:spPr>
          <a:xfrm>
            <a:off x="7636763" y="1172960"/>
            <a:ext cx="9492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14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2D7BF5B4-3B93-E840-BEF4-7CFD7AAAF6D8}"/>
              </a:ext>
            </a:extLst>
          </p:cNvPr>
          <p:cNvSpPr txBox="1"/>
          <p:nvPr/>
        </p:nvSpPr>
        <p:spPr>
          <a:xfrm>
            <a:off x="10133913" y="1183977"/>
            <a:ext cx="9492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14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44DAD509-F9C6-C349-B4F8-EC0916927B85}"/>
              </a:ext>
            </a:extLst>
          </p:cNvPr>
          <p:cNvCxnSpPr>
            <a:cxnSpLocks/>
          </p:cNvCxnSpPr>
          <p:nvPr/>
        </p:nvCxnSpPr>
        <p:spPr>
          <a:xfrm>
            <a:off x="8141157" y="1481097"/>
            <a:ext cx="0" cy="18473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07CFFFCA-ABC8-7045-B3CD-819B49361681}"/>
              </a:ext>
            </a:extLst>
          </p:cNvPr>
          <p:cNvCxnSpPr>
            <a:cxnSpLocks/>
          </p:cNvCxnSpPr>
          <p:nvPr/>
        </p:nvCxnSpPr>
        <p:spPr>
          <a:xfrm>
            <a:off x="10663065" y="1487320"/>
            <a:ext cx="0" cy="184143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2C2B64F4-5AF4-3345-8284-0F6CBD72AAA1}"/>
              </a:ext>
            </a:extLst>
          </p:cNvPr>
          <p:cNvCxnSpPr>
            <a:cxnSpLocks/>
          </p:cNvCxnSpPr>
          <p:nvPr/>
        </p:nvCxnSpPr>
        <p:spPr>
          <a:xfrm>
            <a:off x="9396247" y="1370961"/>
            <a:ext cx="0" cy="22555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3395A11C-FD92-7F4D-AEFF-30D896BFD170}"/>
              </a:ext>
            </a:extLst>
          </p:cNvPr>
          <p:cNvCxnSpPr>
            <a:cxnSpLocks/>
          </p:cNvCxnSpPr>
          <p:nvPr/>
        </p:nvCxnSpPr>
        <p:spPr>
          <a:xfrm flipH="1">
            <a:off x="8803984" y="1366245"/>
            <a:ext cx="112372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5210BF97-0235-A44B-A9A8-CD563FCF4531}"/>
              </a:ext>
            </a:extLst>
          </p:cNvPr>
          <p:cNvSpPr txBox="1"/>
          <p:nvPr/>
        </p:nvSpPr>
        <p:spPr>
          <a:xfrm>
            <a:off x="7772203" y="6020530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13A5F1F3-B5EA-1A4F-A274-921CABECE907}"/>
              </a:ext>
            </a:extLst>
          </p:cNvPr>
          <p:cNvSpPr txBox="1"/>
          <p:nvPr/>
        </p:nvSpPr>
        <p:spPr>
          <a:xfrm>
            <a:off x="9090683" y="6020530"/>
            <a:ext cx="625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A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7992A68C-8DDC-F448-B3C9-F122E53477DF}"/>
              </a:ext>
            </a:extLst>
          </p:cNvPr>
          <p:cNvSpPr txBox="1"/>
          <p:nvPr/>
        </p:nvSpPr>
        <p:spPr>
          <a:xfrm>
            <a:off x="10017611" y="6020530"/>
            <a:ext cx="1317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G-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DAO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1CA5F176-0AB4-B044-9C66-0503C7813E73}"/>
              </a:ext>
            </a:extLst>
          </p:cNvPr>
          <p:cNvSpPr txBox="1"/>
          <p:nvPr/>
        </p:nvSpPr>
        <p:spPr>
          <a:xfrm>
            <a:off x="826346" y="1854681"/>
            <a:ext cx="966931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kumimoji="1" lang="ja-JP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60223F92-B31E-5144-9F99-25C622AA141A}"/>
              </a:ext>
            </a:extLst>
          </p:cNvPr>
          <p:cNvSpPr txBox="1"/>
          <p:nvPr/>
        </p:nvSpPr>
        <p:spPr>
          <a:xfrm>
            <a:off x="961535" y="3318841"/>
            <a:ext cx="670376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A</a:t>
            </a:r>
            <a:endParaRPr kumimoji="1" lang="ja-JP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5985715D-AF57-B544-9650-52851BC1078A}"/>
              </a:ext>
            </a:extLst>
          </p:cNvPr>
          <p:cNvSpPr txBox="1"/>
          <p:nvPr/>
        </p:nvSpPr>
        <p:spPr>
          <a:xfrm>
            <a:off x="247939" y="4797410"/>
            <a:ext cx="154320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G-</a:t>
            </a:r>
            <a:r>
              <a:rPr lang="en-US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DAO</a:t>
            </a:r>
            <a:endParaRPr lang="en-US" altLang="ja-JP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63A8CF5-F2EA-314D-A348-98279123B695}"/>
              </a:ext>
            </a:extLst>
          </p:cNvPr>
          <p:cNvSpPr txBox="1"/>
          <p:nvPr/>
        </p:nvSpPr>
        <p:spPr>
          <a:xfrm>
            <a:off x="9256991" y="1599876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x</a:t>
            </a:r>
            <a:endParaRPr kumimoji="1" lang="ja-JP" altLang="en-US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6858E65-6475-3548-A34E-550A4B980DEC}"/>
              </a:ext>
            </a:extLst>
          </p:cNvPr>
          <p:cNvSpPr txBox="1"/>
          <p:nvPr/>
        </p:nvSpPr>
        <p:spPr>
          <a:xfrm>
            <a:off x="9261156" y="2632386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x</a:t>
            </a:r>
            <a:endParaRPr kumimoji="1" lang="ja-JP" altLang="en-US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945A9DB-1A18-6047-8534-92D85DF72121}"/>
              </a:ext>
            </a:extLst>
          </p:cNvPr>
          <p:cNvSpPr txBox="1"/>
          <p:nvPr/>
        </p:nvSpPr>
        <p:spPr>
          <a:xfrm>
            <a:off x="9262186" y="3722046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x</a:t>
            </a:r>
            <a:endParaRPr kumimoji="1" lang="ja-JP" altLang="en-US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2A56F080-9FFD-EA4D-A7A5-FEAFA33ADFFE}"/>
              </a:ext>
            </a:extLst>
          </p:cNvPr>
          <p:cNvSpPr txBox="1"/>
          <p:nvPr/>
        </p:nvSpPr>
        <p:spPr>
          <a:xfrm>
            <a:off x="10529876" y="4445946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x</a:t>
            </a:r>
            <a:endParaRPr kumimoji="1" lang="ja-JP" altLang="en-US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3461788F-C970-2642-A16E-BAE444501A0B}"/>
              </a:ext>
            </a:extLst>
          </p:cNvPr>
          <p:cNvSpPr txBox="1"/>
          <p:nvPr/>
        </p:nvSpPr>
        <p:spPr>
          <a:xfrm>
            <a:off x="10517406" y="4735506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x</a:t>
            </a:r>
            <a:endParaRPr kumimoji="1" lang="ja-JP" altLang="en-US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FDBAC23-4B9F-2B46-8391-F7F9F5DF7E01}"/>
              </a:ext>
            </a:extLst>
          </p:cNvPr>
          <p:cNvSpPr txBox="1"/>
          <p:nvPr/>
        </p:nvSpPr>
        <p:spPr>
          <a:xfrm>
            <a:off x="10523641" y="4887906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x</a:t>
            </a:r>
            <a:endParaRPr kumimoji="1" lang="ja-JP" altLang="en-US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7057534F-838B-904A-8777-E3E0A5CDEA5B}"/>
              </a:ext>
            </a:extLst>
          </p:cNvPr>
          <p:cNvSpPr txBox="1"/>
          <p:nvPr/>
        </p:nvSpPr>
        <p:spPr>
          <a:xfrm>
            <a:off x="7998996" y="4594536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x</a:t>
            </a:r>
            <a:endParaRPr kumimoji="1" lang="ja-JP" altLang="en-US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4D0C0E4-74EA-834A-A336-379EDB27138A}"/>
              </a:ext>
            </a:extLst>
          </p:cNvPr>
          <p:cNvSpPr txBox="1"/>
          <p:nvPr/>
        </p:nvSpPr>
        <p:spPr>
          <a:xfrm>
            <a:off x="7991376" y="4804086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x</a:t>
            </a:r>
            <a:endParaRPr kumimoji="1" lang="ja-JP" altLang="en-US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1768C942-C134-D542-BB51-CC895ED2458D}"/>
              </a:ext>
            </a:extLst>
          </p:cNvPr>
          <p:cNvSpPr txBox="1"/>
          <p:nvPr/>
        </p:nvSpPr>
        <p:spPr>
          <a:xfrm>
            <a:off x="7995186" y="4956486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x</a:t>
            </a:r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A2C3002-4F1B-6448-93FD-7578F66A8B75}"/>
              </a:ext>
            </a:extLst>
          </p:cNvPr>
          <p:cNvSpPr txBox="1"/>
          <p:nvPr/>
        </p:nvSpPr>
        <p:spPr>
          <a:xfrm>
            <a:off x="6379289" y="1108033"/>
            <a:ext cx="1133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ton Volume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60700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cx1="http://schemas.microsoft.com/office/drawing/2015/9/8/chartex" Requires="cx1">
          <p:graphicFrame>
            <p:nvGraphicFramePr>
              <p:cNvPr id="2" name="グラフ 1">
                <a:extLst>
                  <a:ext uri="{FF2B5EF4-FFF2-40B4-BE49-F238E27FC236}">
                    <a16:creationId xmlns:a16="http://schemas.microsoft.com/office/drawing/2014/main" id="{5B494D4A-4234-FD43-A5C6-ABDA48718CF9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1351592000"/>
                  </p:ext>
                </p:extLst>
              </p:nvPr>
            </p:nvGraphicFramePr>
            <p:xfrm>
              <a:off x="1260441" y="1214200"/>
              <a:ext cx="4572000" cy="488743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3"/>
              </a:graphicData>
            </a:graphic>
          </p:graphicFrame>
        </mc:Choice>
        <mc:Fallback>
          <p:pic>
            <p:nvPicPr>
              <p:cNvPr id="2" name="グラフ 1">
                <a:extLst>
                  <a:ext uri="{FF2B5EF4-FFF2-40B4-BE49-F238E27FC236}">
                    <a16:creationId xmlns:a16="http://schemas.microsoft.com/office/drawing/2014/main" id="{5B494D4A-4234-FD43-A5C6-ABDA48718CF9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260441" y="1214200"/>
                <a:ext cx="4572000" cy="488743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>
        <mc:Choice xmlns:cx1="http://schemas.microsoft.com/office/drawing/2015/9/8/chartex" Requires="cx1">
          <p:graphicFrame>
            <p:nvGraphicFramePr>
              <p:cNvPr id="4" name="グラフ 3">
                <a:extLst>
                  <a:ext uri="{FF2B5EF4-FFF2-40B4-BE49-F238E27FC236}">
                    <a16:creationId xmlns:a16="http://schemas.microsoft.com/office/drawing/2014/main" id="{E43D676D-9A4B-6044-8EC6-88D9505DB218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530424327"/>
                  </p:ext>
                </p:extLst>
              </p:nvPr>
            </p:nvGraphicFramePr>
            <p:xfrm>
              <a:off x="5944997" y="1198759"/>
              <a:ext cx="4572000" cy="4902201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5"/>
              </a:graphicData>
            </a:graphic>
          </p:graphicFrame>
        </mc:Choice>
        <mc:Fallback>
          <p:pic>
            <p:nvPicPr>
              <p:cNvPr id="4" name="グラフ 3">
                <a:extLst>
                  <a:ext uri="{FF2B5EF4-FFF2-40B4-BE49-F238E27FC236}">
                    <a16:creationId xmlns:a16="http://schemas.microsoft.com/office/drawing/2014/main" id="{E43D676D-9A4B-6044-8EC6-88D9505DB218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944997" y="1198759"/>
                <a:ext cx="4572000" cy="4902201"/>
              </a:xfrm>
              <a:prstGeom prst="rect">
                <a:avLst/>
              </a:prstGeom>
            </p:spPr>
          </p:pic>
        </mc:Fallback>
      </mc:AlternateContent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54F4071-1EFB-E544-9E49-26F40E6F87E8}"/>
              </a:ext>
            </a:extLst>
          </p:cNvPr>
          <p:cNvSpPr txBox="1"/>
          <p:nvPr/>
        </p:nvSpPr>
        <p:spPr>
          <a:xfrm>
            <a:off x="7244587" y="6053676"/>
            <a:ext cx="653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85E7227-4DDF-3147-B840-07255C541028}"/>
              </a:ext>
            </a:extLst>
          </p:cNvPr>
          <p:cNvSpPr txBox="1"/>
          <p:nvPr/>
        </p:nvSpPr>
        <p:spPr>
          <a:xfrm>
            <a:off x="8070503" y="6053676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A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70E191B-556E-4549-9C1E-A9C1F4BECEB8}"/>
              </a:ext>
            </a:extLst>
          </p:cNvPr>
          <p:cNvSpPr txBox="1"/>
          <p:nvPr/>
        </p:nvSpPr>
        <p:spPr>
          <a:xfrm>
            <a:off x="8543105" y="6053676"/>
            <a:ext cx="9396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G-</a:t>
            </a:r>
            <a:r>
              <a:rPr kumimoji="1"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DAO</a:t>
            </a:r>
            <a:endParaRPr kumimoji="1" lang="en-US" altLang="ja-JP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B1F6892-2E30-8A4B-85FC-A414F188C8FE}"/>
              </a:ext>
            </a:extLst>
          </p:cNvPr>
          <p:cNvSpPr txBox="1"/>
          <p:nvPr/>
        </p:nvSpPr>
        <p:spPr>
          <a:xfrm>
            <a:off x="2548731" y="6053676"/>
            <a:ext cx="653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7C9A1D5-311C-074F-B6B9-4587A5CC3D6D}"/>
              </a:ext>
            </a:extLst>
          </p:cNvPr>
          <p:cNvSpPr txBox="1"/>
          <p:nvPr/>
        </p:nvSpPr>
        <p:spPr>
          <a:xfrm>
            <a:off x="3360046" y="6053676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A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BE9815F-0077-704E-845D-796FEE9EBE27}"/>
              </a:ext>
            </a:extLst>
          </p:cNvPr>
          <p:cNvSpPr txBox="1"/>
          <p:nvPr/>
        </p:nvSpPr>
        <p:spPr>
          <a:xfrm>
            <a:off x="3886438" y="6053676"/>
            <a:ext cx="9396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G-</a:t>
            </a:r>
            <a:r>
              <a:rPr kumimoji="1"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DAO</a:t>
            </a:r>
            <a:endParaRPr kumimoji="1" lang="en-US" altLang="ja-JP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0CA10AF-AD00-CE45-82D0-4E807D6EEF22}"/>
              </a:ext>
            </a:extLst>
          </p:cNvPr>
          <p:cNvSpPr txBox="1"/>
          <p:nvPr/>
        </p:nvSpPr>
        <p:spPr>
          <a:xfrm>
            <a:off x="3444809" y="91551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0559445-55B3-0444-A671-DF668B98BB4C}"/>
              </a:ext>
            </a:extLst>
          </p:cNvPr>
          <p:cNvSpPr txBox="1"/>
          <p:nvPr/>
        </p:nvSpPr>
        <p:spPr>
          <a:xfrm>
            <a:off x="8087064" y="902648"/>
            <a:ext cx="341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9770927-0B0E-E842-AB3F-4A83D65676DE}"/>
              </a:ext>
            </a:extLst>
          </p:cNvPr>
          <p:cNvSpPr txBox="1"/>
          <p:nvPr/>
        </p:nvSpPr>
        <p:spPr>
          <a:xfrm>
            <a:off x="279690" y="75304"/>
            <a:ext cx="426003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4</a:t>
            </a:r>
            <a:endParaRPr kumimoji="1" lang="ja-JP" altLang="en-US" sz="3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2302E55-EFBC-9242-8D39-A964BC237D16}"/>
              </a:ext>
            </a:extLst>
          </p:cNvPr>
          <p:cNvSpPr txBox="1"/>
          <p:nvPr/>
        </p:nvSpPr>
        <p:spPr>
          <a:xfrm>
            <a:off x="666977" y="892888"/>
            <a:ext cx="15886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EP cells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84837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15</TotalTime>
  <Words>113</Words>
  <Application>Microsoft Macintosh PowerPoint</Application>
  <PresentationFormat>ワイド画面</PresentationFormat>
  <Paragraphs>76</Paragraphs>
  <Slides>5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0" baseType="lpstr">
      <vt:lpstr>游ゴシック</vt:lpstr>
      <vt:lpstr>游ゴシック Light</vt:lpstr>
      <vt:lpstr>Arial</vt:lpstr>
      <vt:lpstr>Times New Roman</vt:lpstr>
      <vt:lpstr>Office テーマ</vt:lpstr>
      <vt:lpstr>Supplement Table 1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Table 1</dc:title>
  <dc:subject/>
  <dc:creator>布井 博幸</dc:creator>
  <cp:keywords/>
  <dc:description/>
  <cp:lastModifiedBy>布井 博幸</cp:lastModifiedBy>
  <cp:revision>19</cp:revision>
  <dcterms:created xsi:type="dcterms:W3CDTF">2021-11-13T16:04:15Z</dcterms:created>
  <dcterms:modified xsi:type="dcterms:W3CDTF">2021-11-29T23:54:23Z</dcterms:modified>
  <cp:category/>
</cp:coreProperties>
</file>